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9926638" cy="1430178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59" d="100"/>
          <a:sy n="59" d="100"/>
        </p:scale>
        <p:origin x="96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evente Kiss" userId="9fbb0f26-f9e0-428d-8b59-d3b09f9fc9b9" providerId="ADAL" clId="{EB45B5C3-BF2F-4469-85E9-F9892CD2A3FF}"/>
    <pc:docChg chg="delSld">
      <pc:chgData name="Levente Kiss" userId="9fbb0f26-f9e0-428d-8b59-d3b09f9fc9b9" providerId="ADAL" clId="{EB45B5C3-BF2F-4469-85E9-F9892CD2A3FF}" dt="2025-08-13T11:57:04.847" v="0" actId="47"/>
      <pc:docMkLst>
        <pc:docMk/>
      </pc:docMkLst>
      <pc:sldChg chg="del">
        <pc:chgData name="Levente Kiss" userId="9fbb0f26-f9e0-428d-8b59-d3b09f9fc9b9" providerId="ADAL" clId="{EB45B5C3-BF2F-4469-85E9-F9892CD2A3FF}" dt="2025-08-13T11:57:04.847" v="0" actId="47"/>
        <pc:sldMkLst>
          <pc:docMk/>
          <pc:sldMk cId="1374799899" sldId="256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B84049-FE5D-3DE2-ACD8-5A449D78146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50BB125-E274-5F9D-65AB-AF4493C4636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038A51-24FA-F7AD-A50A-8017D9164F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DFAA5-66BE-4ED4-87A4-FA7304B56CFE}" type="datetimeFigureOut">
              <a:rPr lang="en-AU" smtClean="0"/>
              <a:t>13/08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875D3B-77D5-7C05-A5AA-88D128D78E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6C5504-0DDB-A6F9-1136-79310CC709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36EAE-372D-4D48-8D24-AED85DAD8D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810424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8993AE-1A32-5E6D-C87B-A67A9F0528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1389E2A-3C22-7DB9-FAFD-61342D2CD2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C2BF72-3982-2B71-DA6D-2F44F03218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DFAA5-66BE-4ED4-87A4-FA7304B56CFE}" type="datetimeFigureOut">
              <a:rPr lang="en-AU" smtClean="0"/>
              <a:t>13/08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A03CB1-8117-71FD-4960-82602B6841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AE6449-7119-6733-57A0-1B0824EC59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36EAE-372D-4D48-8D24-AED85DAD8D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950580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A0F4463-8B9E-86E0-BC62-E0954E8B31B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65D24A2-E836-D607-CA00-1DF92F6F28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70191E-330C-35DF-F4EF-A217CDA68C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DFAA5-66BE-4ED4-87A4-FA7304B56CFE}" type="datetimeFigureOut">
              <a:rPr lang="en-AU" smtClean="0"/>
              <a:t>13/08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730555-EABD-4FED-DF76-504EF4778B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4C99BE-A6B9-34F4-CCC7-27C556E05D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36EAE-372D-4D48-8D24-AED85DAD8D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659553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0378F4-5EA3-4992-46E7-B2ACE5F2FC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C1F1BC-565A-C81C-72AB-97295DA1D57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A50C5B-85CF-E60C-11F6-DE89872B7A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DFAA5-66BE-4ED4-87A4-FA7304B56CFE}" type="datetimeFigureOut">
              <a:rPr lang="en-AU" smtClean="0"/>
              <a:t>13/08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C6FF65-3CC3-A21D-49B2-4DE442E614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C02700-7DD1-D2B1-5096-1892F3D50F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36EAE-372D-4D48-8D24-AED85DAD8D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337892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0E84CF-140F-87CD-CD84-C744AE66FB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0326B80-AE09-3384-93BD-BC7AA2F1CB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FA03EF-3287-5C91-550B-AD746709AF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DFAA5-66BE-4ED4-87A4-FA7304B56CFE}" type="datetimeFigureOut">
              <a:rPr lang="en-AU" smtClean="0"/>
              <a:t>13/08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86A0EE-FAEA-E9F1-14DB-EC2F39181D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92F036-D2E7-01CD-EBEE-670701124C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36EAE-372D-4D48-8D24-AED85DAD8D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962931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44F13D-C198-A1EC-5C5D-FDDBD8E6B9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200A13-4B38-92EA-10B0-DDB556AC786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3DE9D9-2E55-CFC7-26D7-AE8EAB5DBB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24B887-65F7-C4C4-F614-57C202AAFE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DFAA5-66BE-4ED4-87A4-FA7304B56CFE}" type="datetimeFigureOut">
              <a:rPr lang="en-AU" smtClean="0"/>
              <a:t>13/08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2A4A97-E5F9-8831-DB90-155584A746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5AF9AD-0821-4227-5119-38EC79B604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36EAE-372D-4D48-8D24-AED85DAD8D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956363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61C011-F399-FFAC-CCDE-8505D9E146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A376CC-3CB4-9BF8-A710-63E14ABC32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80F8697-5EA6-D8FD-2C45-6B5B599A4D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2145B33-4ADB-B779-D0EF-EAA2D9FAE4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BA76263-30DA-01A3-F8CB-D5D01B88097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B58D387-313E-F28A-FF33-5156261FF4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DFAA5-66BE-4ED4-87A4-FA7304B56CFE}" type="datetimeFigureOut">
              <a:rPr lang="en-AU" smtClean="0"/>
              <a:t>13/08/2025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2749A2E-2D75-A6D7-781E-5870FFD753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346DD3A-115B-509E-6556-1F068206A5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36EAE-372D-4D48-8D24-AED85DAD8D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883581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D4E317-61EC-B23B-DE87-22DE89E48B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DAE7954-FF0C-8078-1E7C-FE6F463D51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DFAA5-66BE-4ED4-87A4-FA7304B56CFE}" type="datetimeFigureOut">
              <a:rPr lang="en-AU" smtClean="0"/>
              <a:t>13/08/2025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45C6E64-6398-F009-C2BE-19E177BC98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8964FB9-290C-94C8-3E48-7D755AD9F6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36EAE-372D-4D48-8D24-AED85DAD8D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58458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7F49087-8267-09A1-7517-C7DDF39F52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DFAA5-66BE-4ED4-87A4-FA7304B56CFE}" type="datetimeFigureOut">
              <a:rPr lang="en-AU" smtClean="0"/>
              <a:t>13/08/2025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866D4BE-EADE-C651-CE16-BCE8962100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8739569-4193-7858-7002-6E23934ADC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36EAE-372D-4D48-8D24-AED85DAD8D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487768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E167E6-1E8D-BD8F-3744-2943D23D7E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A87C3F-6299-7543-A3EF-C78E8EC98CC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B60A47D-3D4B-824E-8E45-CE71244033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3AF16D-B393-5965-975B-0B7A988B7E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DFAA5-66BE-4ED4-87A4-FA7304B56CFE}" type="datetimeFigureOut">
              <a:rPr lang="en-AU" smtClean="0"/>
              <a:t>13/08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7F3773-8F60-640A-1186-F3AD68D4A6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CDE807-536D-64BE-7D42-80B00A5360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36EAE-372D-4D48-8D24-AED85DAD8D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220172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84729E-A0BE-D2B4-EDD3-06B4501A1D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EFDFD56-DE92-7C66-B9E8-F1196A003E7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2243645-0CA2-087D-9B67-769C7D59C0A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4F8E90-8A5B-1369-2544-0B02E09819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DFAA5-66BE-4ED4-87A4-FA7304B56CFE}" type="datetimeFigureOut">
              <a:rPr lang="en-AU" smtClean="0"/>
              <a:t>13/08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FFDA450-8E39-30AB-6A66-AAABDB69B7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9E0858-7995-624F-D338-90AF4205C4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36EAE-372D-4D48-8D24-AED85DAD8D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85659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32A122F-01C5-A09D-3158-57E62A8E1C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BC2760F-7369-B111-565F-55C0ABE200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215244-9883-7110-106A-70B1E785AA0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22DFAA5-66BE-4ED4-87A4-FA7304B56CFE}" type="datetimeFigureOut">
              <a:rPr lang="en-AU" smtClean="0"/>
              <a:t>13/08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1FBD8E-603C-5E28-5090-1F63700AC84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2C1137-F1C4-2493-C4D5-9EE576DD62D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6836EAE-372D-4D48-8D24-AED85DAD8D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702330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97513B4-D1B6-2FE4-E621-861D3808C61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8" name="Group 67">
            <a:extLst>
              <a:ext uri="{FF2B5EF4-FFF2-40B4-BE49-F238E27FC236}">
                <a16:creationId xmlns:a16="http://schemas.microsoft.com/office/drawing/2014/main" id="{7212B99F-9C09-CE14-8E95-E4A563BC1F64}"/>
              </a:ext>
            </a:extLst>
          </p:cNvPr>
          <p:cNvGrpSpPr/>
          <p:nvPr/>
        </p:nvGrpSpPr>
        <p:grpSpPr>
          <a:xfrm>
            <a:off x="69967" y="148140"/>
            <a:ext cx="13071083" cy="6503915"/>
            <a:chOff x="69967" y="148140"/>
            <a:chExt cx="13071083" cy="6503915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65152438-0506-9B97-F25E-3C39C7AD82C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13393" t="11747" r="13571" b="7460"/>
            <a:stretch>
              <a:fillRect/>
            </a:stretch>
          </p:blipFill>
          <p:spPr>
            <a:xfrm>
              <a:off x="69967" y="165500"/>
              <a:ext cx="10424367" cy="6486555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0C0BBB3-5AFA-72A4-2DE5-9E390506C14F}"/>
                </a:ext>
              </a:extLst>
            </p:cNvPr>
            <p:cNvSpPr txBox="1"/>
            <p:nvPr/>
          </p:nvSpPr>
          <p:spPr>
            <a:xfrm>
              <a:off x="189083" y="148140"/>
              <a:ext cx="24329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GYER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Erysiphe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rcuat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Carpinus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etulus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HUNGARY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65330468-E30E-4656-3643-5044EA4BFC44}"/>
                </a:ext>
              </a:extLst>
            </p:cNvPr>
            <p:cNvSpPr txBox="1"/>
            <p:nvPr/>
          </p:nvSpPr>
          <p:spPr>
            <a:xfrm>
              <a:off x="2530532" y="490038"/>
              <a:ext cx="24329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A47b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rthrocladiell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ougeoti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Lycium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arbarum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HUNGARY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4875525-17D5-146A-9782-D6FD52DAF7C2}"/>
                </a:ext>
              </a:extLst>
            </p:cNvPr>
            <p:cNvSpPr txBox="1"/>
            <p:nvPr/>
          </p:nvSpPr>
          <p:spPr>
            <a:xfrm>
              <a:off x="2536322" y="732472"/>
              <a:ext cx="24329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A109a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rthrocladiell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ougeoti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Lycium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arbarum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HUNGARY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90F50FE9-AAD2-303C-78E5-86839DC0F608}"/>
                </a:ext>
              </a:extLst>
            </p:cNvPr>
            <p:cNvSpPr txBox="1"/>
            <p:nvPr/>
          </p:nvSpPr>
          <p:spPr>
            <a:xfrm>
              <a:off x="189086" y="266464"/>
              <a:ext cx="24329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CBS 132220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Erysiphe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necator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Vitis vinifer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ITALY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EBAF868-FC46-F1D3-993F-C476E3E6CFCF}"/>
                </a:ext>
              </a:extLst>
            </p:cNvPr>
            <p:cNvSpPr txBox="1"/>
            <p:nvPr/>
          </p:nvSpPr>
          <p:spPr>
            <a:xfrm>
              <a:off x="2530533" y="612153"/>
              <a:ext cx="24329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CBS 132219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Erysiphe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necator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Vitis vinifer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ITALY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20EE4D0-A6AD-602E-D74D-2DDC4C517F10}"/>
                </a:ext>
              </a:extLst>
            </p:cNvPr>
            <p:cNvSpPr txBox="1"/>
            <p:nvPr/>
          </p:nvSpPr>
          <p:spPr>
            <a:xfrm>
              <a:off x="194876" y="385736"/>
              <a:ext cx="357095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BRIP 72097 </a:t>
              </a:r>
              <a:r>
                <a:rPr lang="en-AU" sz="6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seudoidium</a:t>
              </a:r>
              <a:r>
                <a:rPr lang="en-AU" sz="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hortensiae</a:t>
              </a:r>
              <a:r>
                <a:rPr lang="en-AU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Hydrangea macrophylla</a:t>
              </a:r>
              <a:r>
                <a:rPr lang="en-AU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5802978-3C7C-F602-1F69-971CCFC04F39}"/>
                </a:ext>
              </a:extLst>
            </p:cNvPr>
            <p:cNvSpPr txBox="1"/>
            <p:nvPr/>
          </p:nvSpPr>
          <p:spPr>
            <a:xfrm>
              <a:off x="10113644" y="4459241"/>
              <a:ext cx="24329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RU1b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olovinomyce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Rudbeckia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HUNGARY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25AA806D-59F6-3E4B-2D60-D5D2F6CD791D}"/>
                </a:ext>
              </a:extLst>
            </p:cNvPr>
            <p:cNvSpPr txBox="1"/>
            <p:nvPr/>
          </p:nvSpPr>
          <p:spPr>
            <a:xfrm>
              <a:off x="10113639" y="4574722"/>
              <a:ext cx="24329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RU2a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olovinomyce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Rudbeckia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HUNGARY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B03FF0F2-7BD3-B461-A59C-1C00100B6CD0}"/>
                </a:ext>
              </a:extLst>
            </p:cNvPr>
            <p:cNvSpPr txBox="1"/>
            <p:nvPr/>
          </p:nvSpPr>
          <p:spPr>
            <a:xfrm>
              <a:off x="10113639" y="4693761"/>
              <a:ext cx="24329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RU4b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olovinomyce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Rudbeckia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HUNGARY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081BA23-4D94-508F-A014-9E14F5E8C544}"/>
                </a:ext>
              </a:extLst>
            </p:cNvPr>
            <p:cNvSpPr txBox="1"/>
            <p:nvPr/>
          </p:nvSpPr>
          <p:spPr>
            <a:xfrm>
              <a:off x="10196547" y="4334415"/>
              <a:ext cx="24329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CBS 131.31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olovinomyce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H. tuberosus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USA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D38F22D7-A66C-0A93-1BC6-D4FBFB1F4AE0}"/>
                </a:ext>
              </a:extLst>
            </p:cNvPr>
            <p:cNvSpPr txBox="1"/>
            <p:nvPr/>
          </p:nvSpPr>
          <p:spPr>
            <a:xfrm>
              <a:off x="9463992" y="1997115"/>
              <a:ext cx="24329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Bgr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lumeri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ex undetermined grass CZECHIA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6A0515D9-F68D-1FC1-DEBE-52790CC55D14}"/>
                </a:ext>
              </a:extLst>
            </p:cNvPr>
            <p:cNvSpPr txBox="1"/>
            <p:nvPr/>
          </p:nvSpPr>
          <p:spPr>
            <a:xfrm>
              <a:off x="9458205" y="1177960"/>
              <a:ext cx="24329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BgrB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lumeri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ex undetermined grass CZECHIA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2A3C4BF3-61DF-DDE9-1095-7A4F90B61354}"/>
                </a:ext>
              </a:extLst>
            </p:cNvPr>
            <p:cNvSpPr txBox="1"/>
            <p:nvPr/>
          </p:nvSpPr>
          <p:spPr>
            <a:xfrm>
              <a:off x="9440844" y="2356461"/>
              <a:ext cx="29123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2100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rthrocladiell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ougeoti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Lycium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arbarum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AUSTRALIA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C6E95D95-5B11-45F6-1416-1F595E11D2ED}"/>
                </a:ext>
              </a:extLst>
            </p:cNvPr>
            <p:cNvSpPr txBox="1"/>
            <p:nvPr/>
          </p:nvSpPr>
          <p:spPr>
            <a:xfrm>
              <a:off x="9463992" y="1432734"/>
              <a:ext cx="26580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2110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Erysiphe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ustralian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Lagerstroemi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sp. AUSTRALIA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B0232C82-EBF2-E6F3-6350-397A4D56E1E9}"/>
                </a:ext>
              </a:extLst>
            </p:cNvPr>
            <p:cNvSpPr txBox="1"/>
            <p:nvPr/>
          </p:nvSpPr>
          <p:spPr>
            <a:xfrm>
              <a:off x="9381503" y="3285975"/>
              <a:ext cx="315930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66222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seudoidium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hortensiae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Hydrangea macrophyll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8B91C660-D211-7497-87A0-267BC4B5F918}"/>
                </a:ext>
              </a:extLst>
            </p:cNvPr>
            <p:cNvSpPr txBox="1"/>
            <p:nvPr/>
          </p:nvSpPr>
          <p:spPr>
            <a:xfrm>
              <a:off x="9465876" y="1881634"/>
              <a:ext cx="24329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BgrC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lumeri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ex undetermined grass CZECHIA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9DCFD4B9-EAB6-E385-A40D-43F6C8026B1A}"/>
                </a:ext>
              </a:extLst>
            </p:cNvPr>
            <p:cNvSpPr txBox="1"/>
            <p:nvPr/>
          </p:nvSpPr>
          <p:spPr>
            <a:xfrm>
              <a:off x="9279260" y="3395668"/>
              <a:ext cx="315930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6212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olovinomyce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Salvi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sp. AUSTRALIA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01D4600E-5C2B-BA30-B62C-D73209D09D01}"/>
                </a:ext>
              </a:extLst>
            </p:cNvPr>
            <p:cNvSpPr txBox="1"/>
            <p:nvPr/>
          </p:nvSpPr>
          <p:spPr>
            <a:xfrm>
              <a:off x="9182804" y="3869808"/>
              <a:ext cx="28082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2105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olovinomyce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olay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Cestrum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arqu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B0452A20-66B4-01FC-48C9-FBD2FB50AFDA}"/>
                </a:ext>
              </a:extLst>
            </p:cNvPr>
            <p:cNvSpPr txBox="1"/>
            <p:nvPr/>
          </p:nvSpPr>
          <p:spPr>
            <a:xfrm>
              <a:off x="9452418" y="2121941"/>
              <a:ext cx="29046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6211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olovinomyce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ex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arsonsi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tramine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2E8F02EB-8FCA-32B7-3CD6-C6ACBF89E1AD}"/>
                </a:ext>
              </a:extLst>
            </p:cNvPr>
            <p:cNvSpPr txBox="1"/>
            <p:nvPr/>
          </p:nvSpPr>
          <p:spPr>
            <a:xfrm>
              <a:off x="9177017" y="3745481"/>
              <a:ext cx="28082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BRIP 72107 </a:t>
              </a:r>
              <a:r>
                <a:rPr lang="en-AU" sz="6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olovinomyces</a:t>
              </a:r>
              <a:r>
                <a:rPr lang="en-AU" sz="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olayi</a:t>
              </a:r>
              <a:r>
                <a:rPr lang="en-AU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Cestrum </a:t>
              </a:r>
              <a:r>
                <a:rPr lang="en-AU" sz="6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arqui</a:t>
              </a:r>
              <a:r>
                <a:rPr lang="en-AU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0F518142-606C-3255-9818-8D788C266A9A}"/>
                </a:ext>
              </a:extLst>
            </p:cNvPr>
            <p:cNvSpPr txBox="1"/>
            <p:nvPr/>
          </p:nvSpPr>
          <p:spPr>
            <a:xfrm>
              <a:off x="9177017" y="4100797"/>
              <a:ext cx="28082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2111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olovinomyce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olay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Cestrum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arqu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D688F52C-5E67-3F2B-B33F-88DD51ABE63C}"/>
                </a:ext>
              </a:extLst>
            </p:cNvPr>
            <p:cNvSpPr txBox="1"/>
            <p:nvPr/>
          </p:nvSpPr>
          <p:spPr>
            <a:xfrm>
              <a:off x="9177017" y="3633531"/>
              <a:ext cx="28082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2109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olovinomyce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olay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Cestrum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arqu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E3A97B17-1E25-3A13-374E-D5E2B0801D95}"/>
                </a:ext>
              </a:extLst>
            </p:cNvPr>
            <p:cNvSpPr txBox="1"/>
            <p:nvPr/>
          </p:nvSpPr>
          <p:spPr>
            <a:xfrm>
              <a:off x="9177017" y="3515728"/>
              <a:ext cx="28082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2104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olovinomyce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olay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Cestrum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arqu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C25BED92-CBE7-AEEF-C03B-D6A4512085C9}"/>
                </a:ext>
              </a:extLst>
            </p:cNvPr>
            <p:cNvSpPr txBox="1"/>
            <p:nvPr/>
          </p:nvSpPr>
          <p:spPr>
            <a:xfrm>
              <a:off x="9475566" y="1305968"/>
              <a:ext cx="29046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6210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olovinomyce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ex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arsonsi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tramine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C8755188-E65A-D6B6-425C-B4D47334AB5F}"/>
                </a:ext>
              </a:extLst>
            </p:cNvPr>
            <p:cNvSpPr txBox="1"/>
            <p:nvPr/>
          </p:nvSpPr>
          <p:spPr>
            <a:xfrm>
              <a:off x="9182804" y="3981758"/>
              <a:ext cx="28082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2108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olovinomyce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olay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Cestrum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arqu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5F11D8C9-78DF-BEE6-BEC4-E836525FA45B}"/>
                </a:ext>
              </a:extLst>
            </p:cNvPr>
            <p:cNvSpPr txBox="1"/>
            <p:nvPr/>
          </p:nvSpPr>
          <p:spPr>
            <a:xfrm>
              <a:off x="9452418" y="2237422"/>
              <a:ext cx="357095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2098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seudoidium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hortensiae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Hydrangea macrophyll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A1D21C5C-0BDD-A5B5-9D50-F8369375A851}"/>
                </a:ext>
              </a:extLst>
            </p:cNvPr>
            <p:cNvSpPr txBox="1"/>
            <p:nvPr/>
          </p:nvSpPr>
          <p:spPr>
            <a:xfrm>
              <a:off x="9444886" y="2471903"/>
              <a:ext cx="357095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2099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seudoidium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hortensiae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Hydrangea macrophyll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5B8ADB4D-802E-E7A7-8019-A3B6F1FEB514}"/>
                </a:ext>
              </a:extLst>
            </p:cNvPr>
            <p:cNvSpPr txBox="1"/>
            <p:nvPr/>
          </p:nvSpPr>
          <p:spPr>
            <a:xfrm>
              <a:off x="9475566" y="841795"/>
              <a:ext cx="357095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CBS 132347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Erysiphe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necator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Vitis vinifer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ITALY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9C135143-F676-8064-925E-1382E3FC06F6}"/>
                </a:ext>
              </a:extLst>
            </p:cNvPr>
            <p:cNvSpPr txBox="1"/>
            <p:nvPr/>
          </p:nvSpPr>
          <p:spPr>
            <a:xfrm>
              <a:off x="9452418" y="1079658"/>
              <a:ext cx="357095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DSM 2222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olovinomyce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Cucumis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GERMANY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99FBDB55-9E8D-A6D2-9430-59E84CD8F557}"/>
                </a:ext>
              </a:extLst>
            </p:cNvPr>
            <p:cNvSpPr txBox="1"/>
            <p:nvPr/>
          </p:nvSpPr>
          <p:spPr>
            <a:xfrm>
              <a:off x="9570093" y="959473"/>
              <a:ext cx="357095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Vitis79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Erysiphe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necator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Vitis vinifer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ITALY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C1CC8649-9B10-3B99-DD87-898DE8192969}"/>
                </a:ext>
              </a:extLst>
            </p:cNvPr>
            <p:cNvSpPr txBox="1"/>
            <p:nvPr/>
          </p:nvSpPr>
          <p:spPr>
            <a:xfrm>
              <a:off x="9463992" y="1533156"/>
              <a:ext cx="24329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CBS133.32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Erysiphe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Lonicera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n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USA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FE6A8208-336F-E083-9019-73763224371D}"/>
                </a:ext>
              </a:extLst>
            </p:cNvPr>
            <p:cNvSpPr txBox="1"/>
            <p:nvPr/>
          </p:nvSpPr>
          <p:spPr>
            <a:xfrm>
              <a:off x="9458205" y="1647801"/>
              <a:ext cx="357095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CBS 132225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Erysiphe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necator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Vitis vinifer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HUNGARY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3393E2BC-6F91-02E8-EC1E-5FA8D4C2B3BB}"/>
                </a:ext>
              </a:extLst>
            </p:cNvPr>
            <p:cNvSpPr txBox="1"/>
            <p:nvPr/>
          </p:nvSpPr>
          <p:spPr>
            <a:xfrm>
              <a:off x="9458205" y="1776097"/>
              <a:ext cx="357095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RS1a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odosphaer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annos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Ros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sp. HUNGARY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494097C5-F136-9DC0-AF76-D941C1050580}"/>
                </a:ext>
              </a:extLst>
            </p:cNvPr>
            <p:cNvSpPr txBox="1"/>
            <p:nvPr/>
          </p:nvSpPr>
          <p:spPr>
            <a:xfrm>
              <a:off x="9567337" y="2587384"/>
              <a:ext cx="357095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CBS 132224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Erysiphe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necator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Vitis vinifer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HUNGARY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D457A157-67EF-2487-4EA3-AD822E65806E}"/>
                </a:ext>
              </a:extLst>
            </p:cNvPr>
            <p:cNvSpPr txBox="1"/>
            <p:nvPr/>
          </p:nvSpPr>
          <p:spPr>
            <a:xfrm>
              <a:off x="9353064" y="2709057"/>
              <a:ext cx="276896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ATCC 201056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rthrocladiell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ougeoti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Lycium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arbarum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HUNGARY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026F6072-EFB2-3709-C9D5-74FF343A598B}"/>
                </a:ext>
              </a:extLst>
            </p:cNvPr>
            <p:cNvSpPr txBox="1"/>
            <p:nvPr/>
          </p:nvSpPr>
          <p:spPr>
            <a:xfrm>
              <a:off x="9353063" y="2827800"/>
              <a:ext cx="276896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A11a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rthrocladiell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ougeoti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Lycium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arbarum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HUNGARY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0BFD5DE2-7C85-AB7F-531D-78E6624E1CF3}"/>
                </a:ext>
              </a:extLst>
            </p:cNvPr>
            <p:cNvSpPr txBox="1"/>
            <p:nvPr/>
          </p:nvSpPr>
          <p:spPr>
            <a:xfrm>
              <a:off x="9159656" y="2930659"/>
              <a:ext cx="276896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Trb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Erysiphe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rifoli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Trifolium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HUNGARY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028B8627-015D-EC7C-9149-971B156D037E}"/>
                </a:ext>
              </a:extLst>
            </p:cNvPr>
            <p:cNvSpPr txBox="1"/>
            <p:nvPr/>
          </p:nvSpPr>
          <p:spPr>
            <a:xfrm>
              <a:off x="9165443" y="3055707"/>
              <a:ext cx="24329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LS1a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Erysiphe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ustralian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Lagerstroemi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sp. FRANCE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253C9269-3648-4C3E-E16B-21045D2A101D}"/>
                </a:ext>
              </a:extLst>
            </p:cNvPr>
            <p:cNvSpPr txBox="1"/>
            <p:nvPr/>
          </p:nvSpPr>
          <p:spPr>
            <a:xfrm>
              <a:off x="9141440" y="3171180"/>
              <a:ext cx="276896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A10a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rthrocladiell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ougeoti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Lycium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arbarum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HUNGARY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58F3AE88-EC11-F40F-8697-3A21ABBFD959}"/>
                </a:ext>
              </a:extLst>
            </p:cNvPr>
            <p:cNvSpPr txBox="1"/>
            <p:nvPr/>
          </p:nvSpPr>
          <p:spPr>
            <a:xfrm>
              <a:off x="8780872" y="4802539"/>
              <a:ext cx="28082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2966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odosphaer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xanthi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Vigna radiat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FB90352B-8041-6515-169D-CEAA8FE4E330}"/>
                </a:ext>
              </a:extLst>
            </p:cNvPr>
            <p:cNvSpPr txBox="1"/>
            <p:nvPr/>
          </p:nvSpPr>
          <p:spPr>
            <a:xfrm>
              <a:off x="8784413" y="4915791"/>
              <a:ext cx="28082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2967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odosphaer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xanthi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Vigna radiat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6C5F06DC-5E93-AC6D-85E8-ADB91A57FC76}"/>
                </a:ext>
              </a:extLst>
            </p:cNvPr>
            <p:cNvSpPr txBox="1"/>
            <p:nvPr/>
          </p:nvSpPr>
          <p:spPr>
            <a:xfrm>
              <a:off x="8551916" y="5039543"/>
              <a:ext cx="303715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HMLAC 05119 Undetermined powdery mildew ex </a:t>
              </a:r>
              <a:r>
                <a:rPr lang="en-AU" sz="6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Youngia</a:t>
              </a:r>
              <a:r>
                <a:rPr lang="en-AU" sz="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japonica</a:t>
              </a:r>
              <a:r>
                <a:rPr lang="en-AU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CHINA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1AFF90AE-81A1-0090-65E4-3C67C0D04E14}"/>
                </a:ext>
              </a:extLst>
            </p:cNvPr>
            <p:cNvSpPr txBox="1"/>
            <p:nvPr/>
          </p:nvSpPr>
          <p:spPr>
            <a:xfrm>
              <a:off x="9200694" y="5145965"/>
              <a:ext cx="28082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2968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odosphaer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xanthi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Vigna radiat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0F9ED3BB-31FC-5A4E-DA7E-A5BF5ADFA00C}"/>
                </a:ext>
              </a:extLst>
            </p:cNvPr>
            <p:cNvSpPr txBox="1"/>
            <p:nvPr/>
          </p:nvSpPr>
          <p:spPr>
            <a:xfrm>
              <a:off x="8488407" y="5261258"/>
              <a:ext cx="28082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263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olovinomyce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Artemisia absinthium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CANADA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74E0F0BB-D315-64EB-BCFD-BA98C40A7653}"/>
                </a:ext>
              </a:extLst>
            </p:cNvPr>
            <p:cNvSpPr txBox="1"/>
            <p:nvPr/>
          </p:nvSpPr>
          <p:spPr>
            <a:xfrm>
              <a:off x="8657288" y="5378142"/>
              <a:ext cx="28082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3616Aa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odosphaer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lantagini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lantago lanceolat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FINLAND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07A03ADD-1DE8-031D-BB38-3A34021C4986}"/>
                </a:ext>
              </a:extLst>
            </p:cNvPr>
            <p:cNvSpPr txBox="1"/>
            <p:nvPr/>
          </p:nvSpPr>
          <p:spPr>
            <a:xfrm>
              <a:off x="8478622" y="5500334"/>
              <a:ext cx="28082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9031Aa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odosphaer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lantagini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lantago lanceolat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FINLAND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ADEB81BA-F841-D0F1-696A-5101864E261A}"/>
                </a:ext>
              </a:extLst>
            </p:cNvPr>
            <p:cNvSpPr txBox="1"/>
            <p:nvPr/>
          </p:nvSpPr>
          <p:spPr>
            <a:xfrm>
              <a:off x="8873348" y="5607788"/>
              <a:ext cx="301781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BRIP 72102 </a:t>
              </a:r>
              <a:r>
                <a:rPr lang="en-AU" sz="6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odosphaera</a:t>
              </a:r>
              <a:r>
                <a:rPr lang="en-AU" sz="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lantaginis</a:t>
              </a:r>
              <a:r>
                <a:rPr lang="en-AU" sz="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ex </a:t>
              </a:r>
              <a:r>
                <a:rPr lang="en-AU" sz="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lantago lanceolata</a:t>
              </a:r>
              <a:r>
                <a:rPr lang="en-AU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7A2C7AE2-856E-2C11-E4C6-0F6B9D8BCBA4}"/>
                </a:ext>
              </a:extLst>
            </p:cNvPr>
            <p:cNvSpPr txBox="1"/>
            <p:nvPr/>
          </p:nvSpPr>
          <p:spPr>
            <a:xfrm>
              <a:off x="9037047" y="5729483"/>
              <a:ext cx="28082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2103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odosphaer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lantagini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lantago lanceolat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7A042465-0A86-8F02-6ECA-F40309841DA9}"/>
                </a:ext>
              </a:extLst>
            </p:cNvPr>
            <p:cNvSpPr txBox="1"/>
            <p:nvPr/>
          </p:nvSpPr>
          <p:spPr>
            <a:xfrm>
              <a:off x="8876165" y="5844819"/>
              <a:ext cx="28082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2101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odosphaer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lantagini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lantago lanceolat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C77AC90E-6F69-9D46-D75F-451CF4D9448B}"/>
                </a:ext>
              </a:extLst>
            </p:cNvPr>
            <p:cNvSpPr txBox="1"/>
            <p:nvPr/>
          </p:nvSpPr>
          <p:spPr>
            <a:xfrm>
              <a:off x="8821381" y="5963063"/>
              <a:ext cx="28082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2931Aa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odosphaer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lantagini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lantago lanceolat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FINLAND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05C9FED5-18F7-507B-BCF4-8B5A12B564EB}"/>
                </a:ext>
              </a:extLst>
            </p:cNvPr>
            <p:cNvSpPr txBox="1"/>
            <p:nvPr/>
          </p:nvSpPr>
          <p:spPr>
            <a:xfrm>
              <a:off x="8338442" y="6084758"/>
              <a:ext cx="28082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CBS 129.79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odosphaer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xanthii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Cucurbita pepo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CANADA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8E0D8E5C-2018-7A67-3517-24DA3CDE4AFB}"/>
                </a:ext>
              </a:extLst>
            </p:cNvPr>
            <p:cNvSpPr txBox="1"/>
            <p:nvPr/>
          </p:nvSpPr>
          <p:spPr>
            <a:xfrm>
              <a:off x="8344229" y="6189092"/>
              <a:ext cx="28082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CBS 130.79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odosphaer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xanthii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Cucurbita pepo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CANADA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36FEDE72-3DB1-8545-93DD-6D52FF7AACF8}"/>
                </a:ext>
              </a:extLst>
            </p:cNvPr>
            <p:cNvSpPr txBox="1"/>
            <p:nvPr/>
          </p:nvSpPr>
          <p:spPr>
            <a:xfrm>
              <a:off x="9037047" y="4218206"/>
              <a:ext cx="303715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AQ10 Undetermined powdery mildew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Catha edulis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ISRAEL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5572871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b4fff8a3-050f-428f-b966-cc56f581f9b1}" enabled="1" method="Standard" siteId="{7dfbfb93-19b6-4985-ac7e-501a37938456}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2100</TotalTime>
  <Words>428</Words>
  <Application>Microsoft Office PowerPoint</Application>
  <PresentationFormat>Widescreen</PresentationFormat>
  <Paragraphs>5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>University of Southern Queenslan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evente Kiss</dc:creator>
  <cp:lastModifiedBy>Levente Kiss</cp:lastModifiedBy>
  <cp:revision>2</cp:revision>
  <cp:lastPrinted>2025-07-31T01:07:17Z</cp:lastPrinted>
  <dcterms:created xsi:type="dcterms:W3CDTF">2025-07-29T14:43:21Z</dcterms:created>
  <dcterms:modified xsi:type="dcterms:W3CDTF">2025-08-13T11:57:15Z</dcterms:modified>
</cp:coreProperties>
</file>